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6"/>
  </p:notesMasterIdLst>
  <p:sldIdLst>
    <p:sldId id="256" r:id="rId3"/>
    <p:sldId id="257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78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8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F92357-2328-4E8A-A250-59677EF46B9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B0D5DC-6DD5-4526-B9C9-7ED418538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2172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ary</a:t>
            </a: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igure 2: 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-C)</a:t>
            </a: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t primary cardiomyocyte cultures were analyzed by flow cytometry using human cardiac marker specific antibodies. SIRPA-specific antibody (A) and connexin43- specific antibody (B,C) were applied. To further assess connexin43-positive cells from primary rat cardiomyocyte cultures, human specific marker TRA-1-85 was used for co-immunostaining. Connexin43-positive cells were negative for human-specific marker TRA-1-85. (D) human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TnT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 and human MYH6-specific qPCR 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B20771-1F14-4FAB-B633-4F75DC8BCBDC}" type="slidenum">
              <a:rPr lang="en-CA" smtClean="0">
                <a:solidFill>
                  <a:prstClr val="black"/>
                </a:solidFill>
              </a:rPr>
              <a:pPr/>
              <a:t>3</a:t>
            </a:fld>
            <a:endParaRPr lang="en-CA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74327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0670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99735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359348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10788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75847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543576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555102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234141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01487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090564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8682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9257850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01294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801745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7871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7998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3938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0370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4242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3518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395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4341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730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1552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29063" y="1358782"/>
            <a:ext cx="18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solidFill>
                  <a:prstClr val="black"/>
                </a:solidFill>
              </a:rPr>
              <a:t>A</a:t>
            </a:r>
            <a:endParaRPr lang="en-CA" sz="2400" b="1" dirty="0">
              <a:solidFill>
                <a:prstClr val="black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2963" y="1641654"/>
            <a:ext cx="3324225" cy="360045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8141" y="1641654"/>
            <a:ext cx="3324225" cy="360045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655453" y="1998508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>
                <a:solidFill>
                  <a:prstClr val="black"/>
                </a:solidFill>
              </a:rPr>
              <a:t>Iso</a:t>
            </a:r>
            <a:r>
              <a:rPr lang="en-CA" dirty="0">
                <a:solidFill>
                  <a:prstClr val="black"/>
                </a:solidFill>
              </a:rPr>
              <a:t> PE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81363" y="2005152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SIRPA PE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189925" y="1358782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Rat primary cardiomyocyte culture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1732" y="240896"/>
            <a:ext cx="3103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Supplementary Figure 2</a:t>
            </a:r>
            <a:endParaRPr lang="en-CA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1685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/>
          <a:srcRect t="8047" b="8965"/>
          <a:stretch/>
        </p:blipFill>
        <p:spPr>
          <a:xfrm>
            <a:off x="8546039" y="2490617"/>
            <a:ext cx="3324225" cy="298789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5417" t="6918" r="4021" b="6253"/>
          <a:stretch/>
        </p:blipFill>
        <p:spPr>
          <a:xfrm>
            <a:off x="1017430" y="3728434"/>
            <a:ext cx="3013657" cy="31295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5168" t="8965" r="4561" b="6259"/>
          <a:stretch/>
        </p:blipFill>
        <p:spPr>
          <a:xfrm>
            <a:off x="4077543" y="3805706"/>
            <a:ext cx="3000779" cy="305229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4393" t="8416" r="5338" b="7167"/>
          <a:stretch/>
        </p:blipFill>
        <p:spPr>
          <a:xfrm>
            <a:off x="4077544" y="695458"/>
            <a:ext cx="3000778" cy="303941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l="5834" t="8585" r="6221" b="8071"/>
          <a:stretch/>
        </p:blipFill>
        <p:spPr>
          <a:xfrm>
            <a:off x="1081825" y="708337"/>
            <a:ext cx="2923504" cy="300077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164226" y="2516375"/>
            <a:ext cx="721217" cy="3734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cx43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343954" y="3872382"/>
            <a:ext cx="721217" cy="3734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cx43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645297" y="4665000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TRA-1-85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82982" y="3876538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TRA-1-85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76526" y="734095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>
                <a:solidFill>
                  <a:prstClr val="black"/>
                </a:solidFill>
              </a:rPr>
              <a:t>Iso</a:t>
            </a:r>
            <a:r>
              <a:rPr lang="en-CA" dirty="0">
                <a:solidFill>
                  <a:prstClr val="black"/>
                </a:solidFill>
              </a:rPr>
              <a:t> APC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47375" y="736378"/>
            <a:ext cx="106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>
                <a:solidFill>
                  <a:prstClr val="black"/>
                </a:solidFill>
              </a:rPr>
              <a:t>Iso</a:t>
            </a:r>
            <a:r>
              <a:rPr lang="en-CA" dirty="0">
                <a:solidFill>
                  <a:prstClr val="black"/>
                </a:solidFill>
              </a:rPr>
              <a:t> FITC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54171" y="477504"/>
            <a:ext cx="18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solidFill>
                  <a:prstClr val="black"/>
                </a:solidFill>
              </a:rPr>
              <a:t>B</a:t>
            </a:r>
            <a:endParaRPr lang="en-CA" sz="2400" b="1" dirty="0">
              <a:solidFill>
                <a:prstClr val="black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47808" y="290710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Rat primary cardiomyocyte culture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628845" y="2024059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Rat primary cardiomyocyte culture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094327" y="2393391"/>
            <a:ext cx="18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solidFill>
                  <a:prstClr val="black"/>
                </a:solidFill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39106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80009" y="540092"/>
            <a:ext cx="18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solidFill>
                  <a:prstClr val="black"/>
                </a:solidFill>
              </a:rPr>
              <a:t>D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790" b="1073"/>
          <a:stretch/>
        </p:blipFill>
        <p:spPr>
          <a:xfrm>
            <a:off x="2860313" y="1316021"/>
            <a:ext cx="6245049" cy="204678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35" t="7949" r="4895" b="9724"/>
          <a:stretch/>
        </p:blipFill>
        <p:spPr>
          <a:xfrm>
            <a:off x="3201042" y="1522083"/>
            <a:ext cx="1683375" cy="101743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081374" y="3429304"/>
          <a:ext cx="6013501" cy="2462692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2004500"/>
                <a:gridCol w="1942704"/>
                <a:gridCol w="2066297"/>
              </a:tblGrid>
              <a:tr h="633892">
                <a:tc>
                  <a:txBody>
                    <a:bodyPr/>
                    <a:lstStyle/>
                    <a:p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Human heart cDNA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Rat</a:t>
                      </a:r>
                      <a:r>
                        <a:rPr lang="en-CA" baseline="0" dirty="0" smtClean="0"/>
                        <a:t> primary</a:t>
                      </a:r>
                    </a:p>
                    <a:p>
                      <a:r>
                        <a:rPr lang="en-CA" baseline="0" dirty="0" smtClean="0"/>
                        <a:t>cardiomyocyte culture</a:t>
                      </a:r>
                    </a:p>
                    <a:p>
                      <a:r>
                        <a:rPr lang="en-CA" baseline="0" dirty="0" smtClean="0"/>
                        <a:t>cDNA</a:t>
                      </a:r>
                      <a:endParaRPr lang="en-CA" dirty="0"/>
                    </a:p>
                  </a:txBody>
                  <a:tcPr/>
                </a:tc>
              </a:tr>
              <a:tr h="633892">
                <a:tc>
                  <a:txBody>
                    <a:bodyPr/>
                    <a:lstStyle/>
                    <a:p>
                      <a:r>
                        <a:rPr lang="en-CA" sz="2400" dirty="0" err="1" smtClean="0"/>
                        <a:t>cTnT</a:t>
                      </a:r>
                      <a:endParaRPr lang="en-CA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21.6 ± 4.3 cycles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&gt;45 cycles</a:t>
                      </a:r>
                      <a:endParaRPr lang="en-CA" dirty="0"/>
                    </a:p>
                  </a:txBody>
                  <a:tcPr/>
                </a:tc>
              </a:tr>
              <a:tr h="633892">
                <a:tc>
                  <a:txBody>
                    <a:bodyPr/>
                    <a:lstStyle/>
                    <a:p>
                      <a:r>
                        <a:rPr lang="en-CA" sz="2400" dirty="0" smtClean="0"/>
                        <a:t>MYH6</a:t>
                      </a:r>
                      <a:endParaRPr lang="en-CA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25.85 ± 3.8</a:t>
                      </a:r>
                    </a:p>
                    <a:p>
                      <a:r>
                        <a:rPr lang="en-CA" dirty="0" smtClean="0"/>
                        <a:t>cycles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CA" dirty="0" smtClean="0"/>
                        <a:t>&gt;45 cycles</a:t>
                      </a:r>
                      <a:endParaRPr lang="en-CA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316952" y="1470571"/>
            <a:ext cx="18268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>
                <a:solidFill>
                  <a:prstClr val="black"/>
                </a:solidFill>
              </a:rPr>
              <a:t>Melting Curves</a:t>
            </a:r>
            <a:endParaRPr lang="en-CA" sz="1400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56463" y="1932898"/>
            <a:ext cx="1430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1200" b="1" dirty="0" err="1">
                <a:solidFill>
                  <a:prstClr val="black"/>
                </a:solidFill>
              </a:rPr>
              <a:t>cTnT</a:t>
            </a:r>
            <a:endParaRPr lang="en-CA" sz="1200" b="1" dirty="0">
              <a:solidFill>
                <a:prstClr val="black"/>
              </a:solidFill>
            </a:endParaRPr>
          </a:p>
          <a:p>
            <a:pPr algn="r"/>
            <a:r>
              <a:rPr lang="en-CA" sz="1200" b="1" dirty="0">
                <a:solidFill>
                  <a:prstClr val="black"/>
                </a:solidFill>
              </a:rPr>
              <a:t>Human heart </a:t>
            </a:r>
          </a:p>
          <a:p>
            <a:pPr algn="r"/>
            <a:r>
              <a:rPr lang="en-CA" sz="1200" b="1" dirty="0">
                <a:solidFill>
                  <a:prstClr val="black"/>
                </a:solidFill>
              </a:rPr>
              <a:t>cDNA</a:t>
            </a:r>
            <a:endParaRPr lang="en-CA" sz="1200" b="1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186595" y="1948961"/>
            <a:ext cx="1430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1200" b="1" dirty="0">
                <a:solidFill>
                  <a:prstClr val="black"/>
                </a:solidFill>
              </a:rPr>
              <a:t>MYH6</a:t>
            </a:r>
          </a:p>
          <a:p>
            <a:pPr algn="r"/>
            <a:r>
              <a:rPr lang="en-CA" sz="1200" b="1" dirty="0">
                <a:solidFill>
                  <a:prstClr val="black"/>
                </a:solidFill>
              </a:rPr>
              <a:t>Human heart </a:t>
            </a:r>
          </a:p>
          <a:p>
            <a:pPr algn="r"/>
            <a:r>
              <a:rPr lang="en-CA" sz="1200" b="1" dirty="0">
                <a:solidFill>
                  <a:prstClr val="black"/>
                </a:solidFill>
              </a:rPr>
              <a:t>cDNA</a:t>
            </a:r>
            <a:endParaRPr lang="en-CA" sz="1200" b="1" dirty="0">
              <a:solidFill>
                <a:prstClr val="black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107955" y="2133626"/>
            <a:ext cx="4781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CA" sz="1200" b="1" dirty="0" err="1">
                <a:solidFill>
                  <a:prstClr val="black"/>
                </a:solidFill>
              </a:rPr>
              <a:t>cTnT</a:t>
            </a:r>
            <a:endParaRPr lang="en-CA" sz="1200" b="1" dirty="0">
              <a:solidFill>
                <a:prstClr val="black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316952" y="1932898"/>
            <a:ext cx="5757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CA" sz="1200" b="1" dirty="0">
                <a:solidFill>
                  <a:prstClr val="black"/>
                </a:solidFill>
              </a:rPr>
              <a:t>MYH6</a:t>
            </a:r>
          </a:p>
        </p:txBody>
      </p:sp>
    </p:spTree>
    <p:extLst>
      <p:ext uri="{BB962C8B-B14F-4D97-AF65-F5344CB8AC3E}">
        <p14:creationId xmlns:p14="http://schemas.microsoft.com/office/powerpoint/2010/main" val="1212250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44</Words>
  <Application>Microsoft Office PowerPoint</Application>
  <PresentationFormat>Widescreen</PresentationFormat>
  <Paragraphs>3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zaraz</dc:creator>
  <cp:lastModifiedBy>Peter Szaraz</cp:lastModifiedBy>
  <cp:revision>6</cp:revision>
  <dcterms:created xsi:type="dcterms:W3CDTF">2016-02-12T19:57:45Z</dcterms:created>
  <dcterms:modified xsi:type="dcterms:W3CDTF">2016-02-12T20:03:34Z</dcterms:modified>
</cp:coreProperties>
</file>